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8CF05-75CE-D81B-3958-011A73ED1A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D0A9B5-4BAF-AA20-AD4F-5445568728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A4643-CEAB-ED4A-81F1-B042D4092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D0ED0D-4A3D-4FAA-F91B-CD55D9E1E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12B51B-2E43-599A-6838-96430361F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3544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773E9B-D4E7-E346-FB50-A41E0B8EF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8F6E18-6FA5-C8C9-870D-6A40E72E8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1A1AC-85A5-56DF-9A62-FAA70B931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957D5-0C61-5DC0-82FB-9F74D60DC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46975-8E45-40EA-B91B-BBA29D679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753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D2956C-9585-C3A7-A934-74CA05A15B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EE2285-6BCE-8D45-2114-06BAE74C26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AA9F5-51A9-258E-4259-FFF329757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89E6E3-3081-0DF3-9135-FED78B976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8B459-4246-5546-2666-46848F6AA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82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312D5-92DA-D71D-E7FF-1185C57EFC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493AC3-5838-5686-979F-C4708EAB9D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BCBBE-C65A-1D9B-06AB-5A8291712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BD418-50AA-195E-9EF7-D37BD9647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13E518-5ACE-5576-44E5-BE929C49D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190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AAB84-091F-22D5-3A6C-2DC3AAC4CA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6B9BA-F627-D1E2-DB31-4985C5D271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EE6CB2-E836-6A59-C64E-F2318B43F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1097C-65E4-6523-D969-7CCE35A75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3D516-7B6B-8815-EB85-192C470E3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000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145D4-4F3E-DEF0-E52D-6F199945E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F7D364-D78F-5285-CFE5-28351C6CCB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2EEA0D-DFDD-70C7-2A63-AED7EAD1A1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DA67F-4A1E-0861-4C09-6E66646B3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3E79AA-DD26-89CD-01CC-9892E8406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6D811C-07A8-0FBC-47D4-89DD4BA7B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910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44007-89BB-BD77-871F-B1AA48E1B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7168E8-01A6-B85D-F9AE-23C401953B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7D23E6-9139-D575-2CCF-25C664743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9A8250-CF1B-3354-0556-08C73340F4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45D328-D506-2928-BAF0-05A9108B5A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F467DC-86FD-CA63-923D-03A7C1B09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4FF3B5-B688-9692-22E2-A444F44CC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97691A-9CD4-1274-14E1-AC55E5585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071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66D0E-AD11-EA47-B1DC-01D7E0AA5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D4909-405A-165D-103C-1D7E95FD7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4D9572-0B1D-FE6F-EF95-F5E64844D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BEEC9F-7990-93B9-A120-28D153D8B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03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903C99-819D-1F44-9492-143283919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3F52CA-9FF0-30C6-E2D9-60B1E91C3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E4D404-9C29-4F76-6AAF-687EEF66B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0346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456EAF-B526-28C9-72E1-15BAA3BE8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04110-9824-D35B-CF74-FFAA3E9565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DC3187-603B-0CAB-38C7-E86921C0E7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0FA8D5-E6AF-0212-F67F-ACFA6DFF9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1AD6B2-B43E-F50B-56D6-3F5269625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916575-FF07-F808-8E6F-44012E5A0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8555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2E2D0-C57B-03DC-8B59-6147D3F05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E6B405-2A04-9B3F-CAFC-16C4178268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BA778B-0D30-1763-F06E-00B2F19EF5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E4BFAF-71E0-16DE-2FD1-F17396541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C6507B-296A-BE8A-004A-9B9C54CFE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494F8C-3B05-AC5F-D984-D5693E3AB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141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508D78-3907-9E1F-6C27-99B43B6D1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AEB8E4-6EFD-207A-B4BB-B6258EB5D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4AA7D4-7F64-B9D1-8B5C-9FF21ADEF1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FC2518-AE36-48D1-96F6-74333C097C54}" type="datetimeFigureOut">
              <a:rPr lang="en-GB" smtClean="0"/>
              <a:t>1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2A2B5-108F-6F70-32EE-A377B5418F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433AA-3D25-AA0B-0995-A503FFCDF5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651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4508211-2629-55DA-13C9-ECF99EB75C2B}"/>
              </a:ext>
            </a:extLst>
          </p:cNvPr>
          <p:cNvSpPr txBox="1"/>
          <p:nvPr/>
        </p:nvSpPr>
        <p:spPr>
          <a:xfrm>
            <a:off x="1593751" y="155931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2424702" y="1559312"/>
            <a:ext cx="1111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O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9DE390-5396-151B-3669-F68D32BDDCB7}"/>
              </a:ext>
            </a:extLst>
          </p:cNvPr>
          <p:cNvSpPr txBox="1"/>
          <p:nvPr/>
        </p:nvSpPr>
        <p:spPr>
          <a:xfrm>
            <a:off x="7842205" y="1303748"/>
            <a:ext cx="8643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T54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352A3-1EAE-AA67-1291-F58FFBAE8132}"/>
              </a:ext>
            </a:extLst>
          </p:cNvPr>
          <p:cNvSpPr txBox="1"/>
          <p:nvPr/>
        </p:nvSpPr>
        <p:spPr>
          <a:xfrm>
            <a:off x="6583295" y="1296603"/>
            <a:ext cx="8130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254318-9923-99B2-2653-E7AE07F94C65}"/>
              </a:ext>
            </a:extLst>
          </p:cNvPr>
          <p:cNvSpPr txBox="1"/>
          <p:nvPr/>
        </p:nvSpPr>
        <p:spPr>
          <a:xfrm>
            <a:off x="3932903" y="1282313"/>
            <a:ext cx="1018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AL12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8006B55-BBF6-55B6-3AFF-B359DC7B23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7523" y="1957224"/>
            <a:ext cx="7478944" cy="36556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47443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4508211-2629-55DA-13C9-ECF99EB75C2B}"/>
              </a:ext>
            </a:extLst>
          </p:cNvPr>
          <p:cNvSpPr txBox="1"/>
          <p:nvPr/>
        </p:nvSpPr>
        <p:spPr>
          <a:xfrm>
            <a:off x="1593751" y="155931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2424702" y="1559312"/>
            <a:ext cx="1111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O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9DE390-5396-151B-3669-F68D32BDDCB7}"/>
              </a:ext>
            </a:extLst>
          </p:cNvPr>
          <p:cNvSpPr txBox="1"/>
          <p:nvPr/>
        </p:nvSpPr>
        <p:spPr>
          <a:xfrm>
            <a:off x="3732322" y="1310893"/>
            <a:ext cx="8643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T54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352A3-1EAE-AA67-1291-F58FFBAE8132}"/>
              </a:ext>
            </a:extLst>
          </p:cNvPr>
          <p:cNvSpPr txBox="1"/>
          <p:nvPr/>
        </p:nvSpPr>
        <p:spPr>
          <a:xfrm>
            <a:off x="4862649" y="1296603"/>
            <a:ext cx="8130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254318-9923-99B2-2653-E7AE07F94C65}"/>
              </a:ext>
            </a:extLst>
          </p:cNvPr>
          <p:cNvSpPr txBox="1"/>
          <p:nvPr/>
        </p:nvSpPr>
        <p:spPr>
          <a:xfrm>
            <a:off x="6096000" y="1282313"/>
            <a:ext cx="1018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AL12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A2D2197-9232-E885-7EF3-47CCEE2DDF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5456" y="1928644"/>
            <a:ext cx="5887176" cy="33700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0925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4508211-2629-55DA-13C9-ECF99EB75C2B}"/>
              </a:ext>
            </a:extLst>
          </p:cNvPr>
          <p:cNvSpPr txBox="1"/>
          <p:nvPr/>
        </p:nvSpPr>
        <p:spPr>
          <a:xfrm>
            <a:off x="1593751" y="155931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2424702" y="1559312"/>
            <a:ext cx="1111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O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9DE390-5396-151B-3669-F68D32BDDCB7}"/>
              </a:ext>
            </a:extLst>
          </p:cNvPr>
          <p:cNvSpPr txBox="1"/>
          <p:nvPr/>
        </p:nvSpPr>
        <p:spPr>
          <a:xfrm>
            <a:off x="5208009" y="1282312"/>
            <a:ext cx="8643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T54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352A3-1EAE-AA67-1291-F58FFBAE8132}"/>
              </a:ext>
            </a:extLst>
          </p:cNvPr>
          <p:cNvSpPr txBox="1"/>
          <p:nvPr/>
        </p:nvSpPr>
        <p:spPr>
          <a:xfrm>
            <a:off x="3965435" y="1282313"/>
            <a:ext cx="8130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254318-9923-99B2-2653-E7AE07F94C65}"/>
              </a:ext>
            </a:extLst>
          </p:cNvPr>
          <p:cNvSpPr txBox="1"/>
          <p:nvPr/>
        </p:nvSpPr>
        <p:spPr>
          <a:xfrm>
            <a:off x="6390968" y="1282313"/>
            <a:ext cx="1018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AL12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7669053-B47C-297B-32D8-494CD53B42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642061" y="2539196"/>
            <a:ext cx="3600000" cy="240747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F5CF44B-A863-2332-EBB9-F05830F0BA4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50000"/>
          <a:stretch/>
        </p:blipFill>
        <p:spPr>
          <a:xfrm rot="5400000">
            <a:off x="5236214" y="3130441"/>
            <a:ext cx="3600000" cy="129049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AA0FFA2-25D8-1BA4-84F9-4C249CF2C8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3177492" y="2526780"/>
            <a:ext cx="3600000" cy="24037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1703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</TotalTime>
  <Words>33</Words>
  <Application>Microsoft Office PowerPoint</Application>
  <PresentationFormat>Widescreen</PresentationFormat>
  <Paragraphs>2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11</cp:revision>
  <dcterms:created xsi:type="dcterms:W3CDTF">2024-06-06T16:34:22Z</dcterms:created>
  <dcterms:modified xsi:type="dcterms:W3CDTF">2024-06-18T19:57:12Z</dcterms:modified>
</cp:coreProperties>
</file>